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00" r:id="rId2"/>
    <p:sldId id="301" r:id="rId3"/>
    <p:sldId id="302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7" autoAdjust="0"/>
    <p:restoredTop sz="94660"/>
  </p:normalViewPr>
  <p:slideViewPr>
    <p:cSldViewPr snapToGrid="0">
      <p:cViewPr>
        <p:scale>
          <a:sx n="47" d="100"/>
          <a:sy n="47" d="100"/>
        </p:scale>
        <p:origin x="1408" y="4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76A673-8964-4D80-BA70-56F457CA7A8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7AF144B-4ED9-42B5-99CD-3168A37B941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2C792A-E9EA-45A5-BE7B-4100F56ACA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49D3E-F89B-4767-AC84-B790D149DD96}" type="datetimeFigureOut">
              <a:rPr lang="en-US" smtClean="0"/>
              <a:t>3/2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C267C7-7D08-4CCC-9F81-ED08E07146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666AF3-05A9-49E1-B165-981E6DCD44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2CEF46-F3C8-4799-BA8F-8CE1530DD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76556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C1A8C4-9612-40AA-9E2A-9EA02A811D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D0C6535-782D-40A3-AE49-31431AB3BC4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B18D8D-0002-4A61-8177-A6F6C145D4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49D3E-F89B-4767-AC84-B790D149DD96}" type="datetimeFigureOut">
              <a:rPr lang="en-US" smtClean="0"/>
              <a:t>3/2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94F4EC-A316-4801-9C05-EB407081CC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C81F33-1813-4EAF-876B-86B208985A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2CEF46-F3C8-4799-BA8F-8CE1530DD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16303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DCF8C85-417D-4120-87DA-987D0525150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DC3408C-E371-4CE5-9606-EC0A14632C7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8D84A6-F580-4466-B527-1E359DFEA0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49D3E-F89B-4767-AC84-B790D149DD96}" type="datetimeFigureOut">
              <a:rPr lang="en-US" smtClean="0"/>
              <a:t>3/2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A0CCD4-B55F-44CF-BCC3-AB34303174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F553C4-ADE1-431C-AF71-3956BC141B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2CEF46-F3C8-4799-BA8F-8CE1530DD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67238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F0E77D-5B5F-4CA5-B50D-414B3EFC76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6DE6356-8C24-4BFD-A573-FF7DE0677EE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AA40FD-B002-487C-A713-18112B2591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49D3E-F89B-4767-AC84-B790D149DD96}" type="datetimeFigureOut">
              <a:rPr lang="en-US" smtClean="0"/>
              <a:t>3/2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3139DF-51D1-47A3-B177-DEB1F7E83D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126941-0AD2-4EE4-9042-F908DD763A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2CEF46-F3C8-4799-BA8F-8CE1530DD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38628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1E31DA-9E30-4D27-8247-2E1C8974C6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05F26BE-6253-43CD-83A6-6EAD261CAD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3A82C6-0F79-4627-A52A-B56A52E2E4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49D3E-F89B-4767-AC84-B790D149DD96}" type="datetimeFigureOut">
              <a:rPr lang="en-US" smtClean="0"/>
              <a:t>3/2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B96EC5-4AF7-4148-9830-E685219256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D8301A-3651-406C-A438-BA82C5F829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2CEF46-F3C8-4799-BA8F-8CE1530DD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49865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73EBFB-B12B-42DD-AA89-C21F1CDE5D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FAC86D7-0E32-443B-A307-32ABDAE7E33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7E9C5F9-AED2-4DFD-AB5A-ED1BC4EF979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DD736B2-BBEB-4735-8A11-F72D995679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49D3E-F89B-4767-AC84-B790D149DD96}" type="datetimeFigureOut">
              <a:rPr lang="en-US" smtClean="0"/>
              <a:t>3/22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1DF52B4-4C46-44C4-BFAD-6AE6427F60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72774C0-D00C-4806-A690-D18D7958EF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2CEF46-F3C8-4799-BA8F-8CE1530DD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34876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F80570-1DE8-447F-8A60-D40E632C35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ED3168F-D758-48FE-BE51-9058EE2D9F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B309B4C-FF12-435C-87CF-622D6F4A5B9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3585859-6ECC-49AF-B955-270ACE0359E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9E37A59-5139-4CB2-A0B8-DFC8EB14897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C00C651-CFA9-4183-87B5-76A380C9C7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49D3E-F89B-4767-AC84-B790D149DD96}" type="datetimeFigureOut">
              <a:rPr lang="en-US" smtClean="0"/>
              <a:t>3/22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38F2C75-65FF-41A1-99C0-9285FA09D8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F861A70-DC26-4B3A-A928-5CDB78F87E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2CEF46-F3C8-4799-BA8F-8CE1530DD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17045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1CA9B3-BE86-48CC-BAC6-4399108352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ACADEEA-679F-43C6-973F-8C0D6FE6DC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49D3E-F89B-4767-AC84-B790D149DD96}" type="datetimeFigureOut">
              <a:rPr lang="en-US" smtClean="0"/>
              <a:t>3/22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4350456-3D8E-4F6C-A730-AE6047D73C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CF42AE1-F71F-4947-856B-4CCD38056F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2CEF46-F3C8-4799-BA8F-8CE1530DD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95841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8241729-313F-43E5-B5C9-ABD7B5E2E0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49D3E-F89B-4767-AC84-B790D149DD96}" type="datetimeFigureOut">
              <a:rPr lang="en-US" smtClean="0"/>
              <a:t>3/22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29F47B6-6D24-4B59-9DD3-D544946780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3CA3737-560F-43A3-89A4-623052B287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2CEF46-F3C8-4799-BA8F-8CE1530DD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95890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794507-A07B-4ABC-AAEA-4FC386CBE8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335863C-B21B-4CED-A705-39CCCB5E4EA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300474E-964F-459B-9D7D-BA304ED7FD4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D7332AB-BDCA-43A5-8F01-B42E1F7D45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49D3E-F89B-4767-AC84-B790D149DD96}" type="datetimeFigureOut">
              <a:rPr lang="en-US" smtClean="0"/>
              <a:t>3/22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83A0A99-EEC6-4826-97E4-5061E4087A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AF5AC53-F28F-494F-845C-EF6FD69AB8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2CEF46-F3C8-4799-BA8F-8CE1530DD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39541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63F45A-80A1-4C0D-90CA-378488C067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1D80BFB-A6FF-470A-81D8-C1B51463A54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4E5949F-D798-4824-87F2-D7EA7324C9F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73393FA-919C-41B8-82FC-C9FD976C84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49D3E-F89B-4767-AC84-B790D149DD96}" type="datetimeFigureOut">
              <a:rPr lang="en-US" smtClean="0"/>
              <a:t>3/22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2E8040C-9007-4EB8-A166-F4EC55729D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AB057E5-C4C8-4D17-B5B7-77D3B5271C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2CEF46-F3C8-4799-BA8F-8CE1530DD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38368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EE90B09-5B99-48F6-B932-17715AE5C8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5D2ACFA-B3BB-48CA-9D29-64407702E8F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E6F1A0F-8EB9-48AD-8CFC-F482AE280D6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449D3E-F89B-4767-AC84-B790D149DD96}" type="datetimeFigureOut">
              <a:rPr lang="en-US" smtClean="0"/>
              <a:t>3/2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6778E3-F89D-4E05-992C-DD2DA99D1D4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528F6AE-112B-495A-9FE8-A0E47138F4F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2CEF46-F3C8-4799-BA8F-8CE1530DD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1405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700899-D018-4EE2-BF38-1AFDF8086C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911815" y="144675"/>
            <a:ext cx="6368371" cy="492722"/>
          </a:xfrm>
        </p:spPr>
        <p:txBody>
          <a:bodyPr>
            <a:normAutofit/>
          </a:bodyPr>
          <a:lstStyle/>
          <a:p>
            <a:r>
              <a:rPr lang="en-US" sz="1333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GC-FID Mean values of the quantified fatty acids in </a:t>
            </a:r>
            <a:r>
              <a:rPr lang="en-US" sz="1333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aradelice</a:t>
            </a:r>
            <a:r>
              <a:rPr lang="en-US" sz="1333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EVOO in (%).</a:t>
            </a:r>
            <a:endParaRPr lang="en-US" sz="1333" dirty="0"/>
          </a:p>
        </p:txBody>
      </p:sp>
      <p:pic>
        <p:nvPicPr>
          <p:cNvPr id="5" name="Content Placeholder 4" descr="Diagram&#10;&#10;Description automatically generated">
            <a:extLst>
              <a:ext uri="{FF2B5EF4-FFF2-40B4-BE49-F238E27FC236}">
                <a16:creationId xmlns:a16="http://schemas.microsoft.com/office/drawing/2014/main" id="{83C4E9F3-7932-4410-A2F9-0C2FC3AB68CA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609"/>
          <a:stretch/>
        </p:blipFill>
        <p:spPr>
          <a:xfrm>
            <a:off x="3715748" y="637396"/>
            <a:ext cx="4646677" cy="5889924"/>
          </a:xfrm>
        </p:spPr>
      </p:pic>
    </p:spTree>
    <p:extLst>
      <p:ext uri="{BB962C8B-B14F-4D97-AF65-F5344CB8AC3E}">
        <p14:creationId xmlns:p14="http://schemas.microsoft.com/office/powerpoint/2010/main" val="12988497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47424A-7935-4568-B33C-023D59ACB4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506204" y="55011"/>
            <a:ext cx="5842000" cy="526827"/>
          </a:xfrm>
        </p:spPr>
        <p:txBody>
          <a:bodyPr>
            <a:normAutofit/>
          </a:bodyPr>
          <a:lstStyle/>
          <a:p>
            <a:r>
              <a:rPr lang="en-US" sz="1333" dirty="0"/>
              <a:t>HPLC-UV analysis for total phenolic compounds for </a:t>
            </a:r>
            <a:r>
              <a:rPr lang="en-US" sz="1333" dirty="0" err="1"/>
              <a:t>karadelice</a:t>
            </a:r>
            <a:r>
              <a:rPr lang="en-US" sz="1333" dirty="0"/>
              <a:t> EVOO</a:t>
            </a:r>
          </a:p>
        </p:txBody>
      </p:sp>
      <p:pic>
        <p:nvPicPr>
          <p:cNvPr id="8" name="Picture 7" descr="Diagram, table, engineering drawing&#10;&#10;Description automatically generated">
            <a:extLst>
              <a:ext uri="{FF2B5EF4-FFF2-40B4-BE49-F238E27FC236}">
                <a16:creationId xmlns:a16="http://schemas.microsoft.com/office/drawing/2014/main" id="{78247994-5F31-4D72-AE8B-5D99AD892E0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06205" y="1021956"/>
            <a:ext cx="5170987" cy="545209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517783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396EE5-C4FB-428B-9856-799F65C585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901831" y="111127"/>
            <a:ext cx="5842000" cy="340757"/>
          </a:xfrm>
        </p:spPr>
        <p:txBody>
          <a:bodyPr>
            <a:normAutofit/>
          </a:bodyPr>
          <a:lstStyle/>
          <a:p>
            <a:r>
              <a:rPr lang="en-US" sz="1333" dirty="0"/>
              <a:t>NMR analysis for </a:t>
            </a:r>
            <a:r>
              <a:rPr lang="en-US" sz="1333" dirty="0" err="1"/>
              <a:t>secoiroids</a:t>
            </a:r>
            <a:r>
              <a:rPr lang="en-US" sz="1333" dirty="0"/>
              <a:t> content in mg/kg of </a:t>
            </a:r>
            <a:r>
              <a:rPr lang="en-US" sz="1333" dirty="0" err="1"/>
              <a:t>karadelice</a:t>
            </a:r>
            <a:r>
              <a:rPr lang="en-US" sz="1333" dirty="0"/>
              <a:t> EVOO</a:t>
            </a:r>
          </a:p>
        </p:txBody>
      </p:sp>
      <p:pic>
        <p:nvPicPr>
          <p:cNvPr id="4" name="Picture 3" descr="Text&#10;&#10;Description automatically generated">
            <a:extLst>
              <a:ext uri="{FF2B5EF4-FFF2-40B4-BE49-F238E27FC236}">
                <a16:creationId xmlns:a16="http://schemas.microsoft.com/office/drawing/2014/main" id="{58D95AF3-0AC1-4631-9A69-0B6C3EF09E0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13520" y="485952"/>
            <a:ext cx="4212748" cy="61276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157673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35</Words>
  <Application>Microsoft Office PowerPoint</Application>
  <PresentationFormat>Widescreen</PresentationFormat>
  <Paragraphs>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 GC-FID Mean values of the quantified fatty acids in karadelice EVOO in (%).</vt:lpstr>
      <vt:lpstr>HPLC-UV analysis for total phenolic compounds for karadelice EVOO</vt:lpstr>
      <vt:lpstr>NMR analysis for secoiroids content in mg/kg of karadelice EVOO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ussama badad</dc:creator>
  <cp:lastModifiedBy>oussama badad</cp:lastModifiedBy>
  <cp:revision>2</cp:revision>
  <dcterms:created xsi:type="dcterms:W3CDTF">2021-03-22T23:13:07Z</dcterms:created>
  <dcterms:modified xsi:type="dcterms:W3CDTF">2021-03-22T23:17:15Z</dcterms:modified>
</cp:coreProperties>
</file>